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321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538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18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2136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156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233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579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368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499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903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346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DF472-6695-4A45-8D43-3D937282BE5D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FAE28-D6D8-0F44-AF46-F42A4A830D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114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AAD9F9B-5935-1E68-D05E-94C87B0EF869}"/>
              </a:ext>
            </a:extLst>
          </p:cNvPr>
          <p:cNvSpPr txBox="1"/>
          <p:nvPr/>
        </p:nvSpPr>
        <p:spPr>
          <a:xfrm>
            <a:off x="360000" y="4207613"/>
            <a:ext cx="12791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Diffuse type (Exon 4-8)</a:t>
            </a:r>
            <a:endParaRPr kumimoji="1" lang="ja-JP" altLang="en-US" sz="1600" b="1">
              <a:latin typeface="Times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8F7D1DB-C84A-8C27-942B-DF89B1E56131}"/>
              </a:ext>
            </a:extLst>
          </p:cNvPr>
          <p:cNvSpPr txBox="1"/>
          <p:nvPr/>
        </p:nvSpPr>
        <p:spPr>
          <a:xfrm>
            <a:off x="360000" y="1507613"/>
            <a:ext cx="14381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Intestinal type </a:t>
            </a:r>
          </a:p>
          <a:p>
            <a:r>
              <a:rPr kumimoji="1" lang="en-US" altLang="ja-JP" sz="1600" b="1" dirty="0">
                <a:latin typeface="Times" pitchFamily="2" charset="0"/>
              </a:rPr>
              <a:t>(Exon 4-8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8293A40-804E-369D-2AC6-DE1A46294871}"/>
              </a:ext>
            </a:extLst>
          </p:cNvPr>
          <p:cNvSpPr txBox="1"/>
          <p:nvPr/>
        </p:nvSpPr>
        <p:spPr>
          <a:xfrm>
            <a:off x="5198541" y="180000"/>
            <a:ext cx="7559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China</a:t>
            </a:r>
            <a:endParaRPr kumimoji="1" lang="ja-JP" altLang="en-US" sz="1600" b="1">
              <a:latin typeface="Times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4C43EB4-C920-27CF-A373-9384B2EA5A4D}"/>
              </a:ext>
            </a:extLst>
          </p:cNvPr>
          <p:cNvSpPr txBox="1"/>
          <p:nvPr/>
        </p:nvSpPr>
        <p:spPr>
          <a:xfrm>
            <a:off x="7680744" y="180000"/>
            <a:ext cx="8315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Japan</a:t>
            </a:r>
            <a:endParaRPr kumimoji="1" lang="ja-JP" altLang="en-US" b="1">
              <a:latin typeface="Times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0384178-8925-2F4C-4563-CA3B544669B9}"/>
              </a:ext>
            </a:extLst>
          </p:cNvPr>
          <p:cNvSpPr txBox="1"/>
          <p:nvPr/>
        </p:nvSpPr>
        <p:spPr>
          <a:xfrm>
            <a:off x="2276965" y="180000"/>
            <a:ext cx="15660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</a:rPr>
              <a:t>Eastern Europe</a:t>
            </a:r>
            <a:endParaRPr kumimoji="1" lang="ja-JP" altLang="en-US" sz="1600" b="1">
              <a:latin typeface="Times" pitchFamily="2" charset="0"/>
            </a:endParaRPr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20B5E17F-26FC-A947-2807-B0F97CAF66C9}"/>
              </a:ext>
            </a:extLst>
          </p:cNvPr>
          <p:cNvGrpSpPr/>
          <p:nvPr/>
        </p:nvGrpSpPr>
        <p:grpSpPr>
          <a:xfrm>
            <a:off x="1494646" y="5760000"/>
            <a:ext cx="8163725" cy="1089332"/>
            <a:chOff x="540000" y="5760000"/>
            <a:chExt cx="8163725" cy="1089332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67540A75-4916-4E53-5167-FA4ED27FBFE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880000" y="5854666"/>
              <a:ext cx="180000" cy="1800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CCE1103-F7A5-A626-13C9-55F95B4915DB}"/>
                </a:ext>
              </a:extLst>
            </p:cNvPr>
            <p:cNvSpPr txBox="1"/>
            <p:nvPr/>
          </p:nvSpPr>
          <p:spPr>
            <a:xfrm>
              <a:off x="3060000" y="5760000"/>
              <a:ext cx="20580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G:C&gt;A:T at non-CpG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E8DD5185-1D2A-8446-8140-F0E73C3178E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0000" y="6214666"/>
              <a:ext cx="180000" cy="1800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AFAC823-4C8B-24C7-09C0-34CFD0D70DC9}"/>
                </a:ext>
              </a:extLst>
            </p:cNvPr>
            <p:cNvSpPr txBox="1"/>
            <p:nvPr/>
          </p:nvSpPr>
          <p:spPr>
            <a:xfrm>
              <a:off x="720000" y="6120000"/>
              <a:ext cx="9245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G:C&gt;T:A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7D45EC07-F765-E526-09C6-A1AD5B12B2B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20000" y="5854666"/>
              <a:ext cx="180000" cy="1800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24C6E0EC-8914-55A2-07EF-2AB56A73FEC1}"/>
                </a:ext>
              </a:extLst>
            </p:cNvPr>
            <p:cNvSpPr txBox="1"/>
            <p:nvPr/>
          </p:nvSpPr>
          <p:spPr>
            <a:xfrm>
              <a:off x="5400000" y="5760000"/>
              <a:ext cx="9396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A:T&gt;G:C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09D5E15A-04B2-318B-2600-5FBDE28EC61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0000" y="6574666"/>
              <a:ext cx="180000" cy="180000"/>
            </a:xfrm>
            <a:prstGeom prst="rect">
              <a:avLst/>
            </a:prstGeom>
            <a:solidFill>
              <a:srgbClr val="63636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BCE150FC-4F5E-245C-9944-001C0B6B5154}"/>
                </a:ext>
              </a:extLst>
            </p:cNvPr>
            <p:cNvSpPr txBox="1"/>
            <p:nvPr/>
          </p:nvSpPr>
          <p:spPr>
            <a:xfrm>
              <a:off x="720000" y="6480000"/>
              <a:ext cx="7601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>
                  <a:latin typeface="Calibri" panose="020F0502020204030204" pitchFamily="34" charset="0"/>
                  <a:cs typeface="Calibri" panose="020F0502020204030204" pitchFamily="34" charset="0"/>
                </a:rPr>
                <a:t>Delins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1A133AE7-9556-085F-2E02-11D9CF23320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0000" y="5854666"/>
              <a:ext cx="180000" cy="180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A79B84F-DB1D-A998-E86A-CE302E782089}"/>
                </a:ext>
              </a:extLst>
            </p:cNvPr>
            <p:cNvSpPr txBox="1"/>
            <p:nvPr/>
          </p:nvSpPr>
          <p:spPr>
            <a:xfrm>
              <a:off x="720000" y="5760000"/>
              <a:ext cx="16220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G:C&gt;A:T at CpG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33D65DEE-5C39-549A-C7DA-6734A381088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60000" y="5854666"/>
              <a:ext cx="180000" cy="1800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CCC5EF3-3892-4747-F0D7-B2A1300CF4A1}"/>
                </a:ext>
              </a:extLst>
            </p:cNvPr>
            <p:cNvSpPr txBox="1"/>
            <p:nvPr/>
          </p:nvSpPr>
          <p:spPr>
            <a:xfrm>
              <a:off x="7740000" y="5760000"/>
              <a:ext cx="9637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G:C&gt;C:G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F52E6403-17F2-D82B-6325-0069D363D4D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60000" y="6214666"/>
              <a:ext cx="180000" cy="180000"/>
            </a:xfrm>
            <a:prstGeom prst="rect">
              <a:avLst/>
            </a:prstGeom>
            <a:solidFill>
              <a:srgbClr val="9E470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C833D481-1B3A-041C-42C9-8C298020D563}"/>
                </a:ext>
              </a:extLst>
            </p:cNvPr>
            <p:cNvSpPr txBox="1"/>
            <p:nvPr/>
          </p:nvSpPr>
          <p:spPr>
            <a:xfrm>
              <a:off x="7740000" y="6120000"/>
              <a:ext cx="4956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Del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28F3FAE4-9E6B-A22A-721F-CF0BD5B7686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880000" y="6214666"/>
              <a:ext cx="180000" cy="1800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CE99DC5C-409D-8F92-926B-10F07416ED10}"/>
                </a:ext>
              </a:extLst>
            </p:cNvPr>
            <p:cNvSpPr txBox="1"/>
            <p:nvPr/>
          </p:nvSpPr>
          <p:spPr>
            <a:xfrm>
              <a:off x="3060000" y="6120000"/>
              <a:ext cx="9396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A:T&gt;C:G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5C4F5C99-6066-FCDE-4D3E-438641364FD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20000" y="6214666"/>
              <a:ext cx="180000" cy="180000"/>
            </a:xfrm>
            <a:prstGeom prst="rect">
              <a:avLst/>
            </a:prstGeom>
            <a:solidFill>
              <a:srgbClr val="24437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28FD4501-B02A-E630-3C1F-4D424A3B8DAC}"/>
                </a:ext>
              </a:extLst>
            </p:cNvPr>
            <p:cNvSpPr txBox="1"/>
            <p:nvPr/>
          </p:nvSpPr>
          <p:spPr>
            <a:xfrm>
              <a:off x="5400000" y="6120000"/>
              <a:ext cx="9005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A:T&gt;T:A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D02AADE8-2C3E-A3F3-80A3-ABE68A35ADF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880000" y="6574666"/>
              <a:ext cx="180000" cy="180000"/>
            </a:xfrm>
            <a:prstGeom prst="rect">
              <a:avLst/>
            </a:prstGeom>
            <a:solidFill>
              <a:srgbClr val="9A720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03BEBF9A-1D7A-33C4-E15A-2A676A46E3B2}"/>
                </a:ext>
              </a:extLst>
            </p:cNvPr>
            <p:cNvSpPr txBox="1"/>
            <p:nvPr/>
          </p:nvSpPr>
          <p:spPr>
            <a:xfrm>
              <a:off x="3060000" y="6480000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Ins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AED4CF20-2195-4B0A-E4B7-ADDB12C4A3B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20000" y="6574666"/>
              <a:ext cx="180000" cy="180000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rgbClr val="00549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79F954A4-3CE7-2F52-557B-F795303C3586}"/>
                </a:ext>
              </a:extLst>
            </p:cNvPr>
            <p:cNvSpPr txBox="1"/>
            <p:nvPr/>
          </p:nvSpPr>
          <p:spPr>
            <a:xfrm>
              <a:off x="5400000" y="6480000"/>
              <a:ext cx="9622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S</a:t>
              </a:r>
              <a:r>
                <a:rPr kumimoji="1" lang="en-US" altLang="ja-JP">
                  <a:latin typeface="Calibri" panose="020F0502020204030204" pitchFamily="34" charset="0"/>
                  <a:cs typeface="Calibri" panose="020F0502020204030204" pitchFamily="34" charset="0"/>
                </a:rPr>
                <a:t>plice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49E47046-04C7-1806-AB4E-A756DD8E7822}"/>
              </a:ext>
            </a:extLst>
          </p:cNvPr>
          <p:cNvGrpSpPr/>
          <p:nvPr/>
        </p:nvGrpSpPr>
        <p:grpSpPr>
          <a:xfrm>
            <a:off x="1800000" y="540000"/>
            <a:ext cx="7560000" cy="5220000"/>
            <a:chOff x="1800000" y="540000"/>
            <a:chExt cx="7560000" cy="5220000"/>
          </a:xfrm>
        </p:grpSpPr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42D1226E-A540-7B23-E40C-7060C17BFE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00000" y="3240000"/>
              <a:ext cx="2520000" cy="2520000"/>
            </a:xfrm>
            <a:prstGeom prst="rect">
              <a:avLst/>
            </a:prstGeom>
          </p:spPr>
        </p:pic>
        <p:pic>
          <p:nvPicPr>
            <p:cNvPr id="44" name="図 43">
              <a:extLst>
                <a:ext uri="{FF2B5EF4-FFF2-40B4-BE49-F238E27FC236}">
                  <a16:creationId xmlns:a16="http://schemas.microsoft.com/office/drawing/2014/main" id="{058FB588-670E-CB7C-BC89-E11AC700138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20000" y="3240000"/>
              <a:ext cx="2520000" cy="2520000"/>
            </a:xfrm>
            <a:prstGeom prst="rect">
              <a:avLst/>
            </a:prstGeom>
          </p:spPr>
        </p:pic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D20C1D08-A763-9874-54C2-4E5E5A198D9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840000" y="3240000"/>
              <a:ext cx="2520000" cy="2520000"/>
            </a:xfrm>
            <a:prstGeom prst="rect">
              <a:avLst/>
            </a:prstGeom>
          </p:spPr>
        </p:pic>
        <p:pic>
          <p:nvPicPr>
            <p:cNvPr id="46" name="図 45">
              <a:extLst>
                <a:ext uri="{FF2B5EF4-FFF2-40B4-BE49-F238E27FC236}">
                  <a16:creationId xmlns:a16="http://schemas.microsoft.com/office/drawing/2014/main" id="{1C24977F-90B9-7045-6A96-CBBC3C397B5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00000" y="540000"/>
              <a:ext cx="2520000" cy="2520000"/>
            </a:xfrm>
            <a:prstGeom prst="rect">
              <a:avLst/>
            </a:prstGeom>
          </p:spPr>
        </p:pic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D643AB57-072F-CD7A-5D1B-ED97F2B0682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20000" y="540000"/>
              <a:ext cx="2520000" cy="2520000"/>
            </a:xfrm>
            <a:prstGeom prst="rect">
              <a:avLst/>
            </a:prstGeom>
          </p:spPr>
        </p:pic>
        <p:pic>
          <p:nvPicPr>
            <p:cNvPr id="48" name="図 47">
              <a:extLst>
                <a:ext uri="{FF2B5EF4-FFF2-40B4-BE49-F238E27FC236}">
                  <a16:creationId xmlns:a16="http://schemas.microsoft.com/office/drawing/2014/main" id="{D5E09F9E-444F-5D63-B9A6-8B0C0A778D2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840000" y="540000"/>
              <a:ext cx="2520000" cy="2520000"/>
            </a:xfrm>
            <a:prstGeom prst="rect">
              <a:avLst/>
            </a:prstGeom>
          </p:spPr>
        </p:pic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F55E3A2-C903-2217-F6AA-5D8D5D6908CB}"/>
              </a:ext>
            </a:extLst>
          </p:cNvPr>
          <p:cNvSpPr txBox="1"/>
          <p:nvPr/>
        </p:nvSpPr>
        <p:spPr>
          <a:xfrm>
            <a:off x="0" y="0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Fig. </a:t>
            </a:r>
            <a:r>
              <a:rPr kumimoji="1" lang="en-US" altLang="ja-JP" b="1">
                <a:latin typeface="Times" pitchFamily="2" charset="0"/>
              </a:rPr>
              <a:t>S3 </a:t>
            </a:r>
            <a:endParaRPr kumimoji="1" lang="ja-JP" altLang="en-US" b="1">
              <a:latin typeface="Times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371771E-1782-D870-A1D7-B27E7120F5E7}"/>
              </a:ext>
            </a:extLst>
          </p:cNvPr>
          <p:cNvSpPr txBox="1"/>
          <p:nvPr/>
        </p:nvSpPr>
        <p:spPr>
          <a:xfrm>
            <a:off x="6072710" y="508448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itchFamily="2" charset="0"/>
              </a:rPr>
              <a:t>*</a:t>
            </a:r>
            <a:endParaRPr kumimoji="1" lang="ja-JP" altLang="en-US" sz="1200">
              <a:latin typeface="Times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B0D2CED-5A6B-8838-E5D2-583660237DD5}"/>
              </a:ext>
            </a:extLst>
          </p:cNvPr>
          <p:cNvSpPr txBox="1"/>
          <p:nvPr/>
        </p:nvSpPr>
        <p:spPr>
          <a:xfrm>
            <a:off x="8593405" y="507774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itchFamily="2" charset="0"/>
              </a:rPr>
              <a:t>*</a:t>
            </a:r>
            <a:endParaRPr kumimoji="1" lang="ja-JP" altLang="en-US" sz="120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7229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78</Words>
  <Application>Microsoft Macintosh PowerPoint</Application>
  <PresentationFormat>A4 210 x 297 mm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英孝</dc:creator>
  <cp:lastModifiedBy>山田 英孝</cp:lastModifiedBy>
  <cp:revision>4</cp:revision>
  <dcterms:created xsi:type="dcterms:W3CDTF">2022-09-20T06:57:30Z</dcterms:created>
  <dcterms:modified xsi:type="dcterms:W3CDTF">2022-09-26T00:34:31Z</dcterms:modified>
</cp:coreProperties>
</file>